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7D587-5920-45EB-8011-7E745378E1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B632D-6DED-4E15-8342-EEBEAAD0BD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57D441-19BF-4574-8196-0230ED724D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8C4D9-55F7-47E2-AA78-1812468214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1CB07-A75A-4A0F-BDE9-FA5B4DBDF6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34F44-7301-4352-964B-3912A0200A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1A857-5A9D-4C99-8208-0A9A5138AD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00A7FF-10DD-4930-923D-38CB18B28B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F3F39B-49A8-45C7-B79F-9E2E0771A7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77C66-7B7B-471E-9103-4FD5A27BB9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9F467-3B09-4E1D-B8B6-1857934EE0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CAD3F-E67C-4A4C-BF08-609AA5D5D2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B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A42898-885E-4AA6-9888-A1F508441692}" type="slidenum">
              <a:rPr b="0" lang="fr-B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908000" y="1197000"/>
            <a:ext cx="4996080" cy="302400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4"/>
          <p:cNvSpPr/>
          <p:nvPr/>
        </p:nvSpPr>
        <p:spPr>
          <a:xfrm>
            <a:off x="2044440" y="2170080"/>
            <a:ext cx="38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ZoneTexte 5"/>
          <p:cNvSpPr/>
          <p:nvPr/>
        </p:nvSpPr>
        <p:spPr>
          <a:xfrm>
            <a:off x="3620520" y="20178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6"/>
          <p:cNvSpPr/>
          <p:nvPr/>
        </p:nvSpPr>
        <p:spPr>
          <a:xfrm>
            <a:off x="4101480" y="153828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ZoneTexte 8"/>
          <p:cNvSpPr/>
          <p:nvPr/>
        </p:nvSpPr>
        <p:spPr>
          <a:xfrm>
            <a:off x="5411160" y="195732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ZoneTexte 9"/>
          <p:cNvSpPr/>
          <p:nvPr/>
        </p:nvSpPr>
        <p:spPr>
          <a:xfrm>
            <a:off x="5652360" y="16002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ZoneTexte 10"/>
          <p:cNvSpPr/>
          <p:nvPr/>
        </p:nvSpPr>
        <p:spPr>
          <a:xfrm>
            <a:off x="5996160" y="160812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ZoneTexte 11"/>
          <p:cNvSpPr/>
          <p:nvPr/>
        </p:nvSpPr>
        <p:spPr>
          <a:xfrm>
            <a:off x="6261840" y="144792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7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ZoneTexte 12"/>
          <p:cNvSpPr/>
          <p:nvPr/>
        </p:nvSpPr>
        <p:spPr>
          <a:xfrm>
            <a:off x="6484320" y="15858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ZoneTexte 13"/>
          <p:cNvSpPr/>
          <p:nvPr/>
        </p:nvSpPr>
        <p:spPr>
          <a:xfrm>
            <a:off x="6600960" y="1547640"/>
            <a:ext cx="41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R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ZoneTexte 14"/>
          <p:cNvSpPr/>
          <p:nvPr/>
        </p:nvSpPr>
        <p:spPr>
          <a:xfrm>
            <a:off x="5133960" y="154764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ZoneTexte 17"/>
          <p:cNvSpPr/>
          <p:nvPr/>
        </p:nvSpPr>
        <p:spPr>
          <a:xfrm>
            <a:off x="112320" y="115920"/>
            <a:ext cx="103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ZoneTexte 18"/>
          <p:cNvSpPr/>
          <p:nvPr/>
        </p:nvSpPr>
        <p:spPr>
          <a:xfrm>
            <a:off x="1118160" y="907920"/>
            <a:ext cx="357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ZoneTexte 19"/>
          <p:cNvSpPr/>
          <p:nvPr/>
        </p:nvSpPr>
        <p:spPr>
          <a:xfrm>
            <a:off x="1189440" y="4149720"/>
            <a:ext cx="346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22"/>
          <p:cNvSpPr/>
          <p:nvPr/>
        </p:nvSpPr>
        <p:spPr>
          <a:xfrm>
            <a:off x="1332000" y="5041800"/>
            <a:ext cx="7343640" cy="132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1-14_Or1: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15400-15700bp_      --GCCCAGGAGGC</a:t>
            </a:r>
            <a:r>
              <a:rPr b="0" lang="fr-FR" sz="900" spc="-1" strike="noStrike">
                <a:solidFill>
                  <a:srgbClr val="ff0000"/>
                </a:solidFill>
                <a:latin typeface="Courier New"/>
                <a:ea typeface="Courier New"/>
              </a:rPr>
              <a:t>GTCAC&lt;&gt;AGTAC</a:t>
            </a: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GGAACCCCA--------GATG--TTCGGTCTTTTGCC 201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20150-20450bp_      TAGTTCAGCTTTC</a:t>
            </a:r>
            <a:r>
              <a:rPr b="0" lang="fr-FR" sz="900" spc="-1" strike="noStrike">
                <a:solidFill>
                  <a:srgbClr val="ff0000"/>
                </a:solidFill>
                <a:latin typeface="Courier New"/>
                <a:ea typeface="Courier New"/>
              </a:rPr>
              <a:t>GTCAT&lt;&gt;AGTAC</a:t>
            </a: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A-CCACCTT--------GTCG--CTAGTCCTGAGTAC 202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30400-30700bp_      TACCAGCAGACTC</a:t>
            </a:r>
            <a:r>
              <a:rPr b="0" lang="fr-FR" sz="900" spc="-1" strike="noStrike">
                <a:solidFill>
                  <a:srgbClr val="ff0000"/>
                </a:solidFill>
                <a:latin typeface="Courier New"/>
                <a:ea typeface="Courier New"/>
              </a:rPr>
              <a:t>GTCAT&lt;&gt;AGTAC</a:t>
            </a: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CCGCTG--TAATCCG--AGTCA-TCCGTAGCAGGCTC 19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32950-33250bp_      TGCTTCCTTGATC</a:t>
            </a:r>
            <a:r>
              <a:rPr b="0" lang="fr-FR" sz="900" spc="-1" strike="noStrike">
                <a:solidFill>
                  <a:srgbClr val="ff0000"/>
                </a:solidFill>
                <a:latin typeface="Courier New"/>
                <a:ea typeface="Courier New"/>
              </a:rPr>
              <a:t>GTCAT&lt;&gt;AGTAC</a:t>
            </a: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TCCCCG-----------AGGTATTGCTTCCAGGCGTC 18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35300-35600bp_      TCCCG--TGAAT-</a:t>
            </a:r>
            <a:r>
              <a:rPr b="0" lang="fr-FR" sz="900" spc="-1" strike="noStrike">
                <a:solidFill>
                  <a:srgbClr val="ff0000"/>
                </a:solidFill>
                <a:latin typeface="Courier New"/>
                <a:ea typeface="Courier New"/>
              </a:rPr>
              <a:t>GTCAT&lt;&gt;AGTAC</a:t>
            </a: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CCGCTGGCCGGTCTGTCGGTCACTACATCACTGAAGC 189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38700-39000bp_      TT--       -C</a:t>
            </a:r>
            <a:r>
              <a:rPr b="0" lang="fr-FR" sz="900" spc="-1" strike="noStrike">
                <a:solidFill>
                  <a:srgbClr val="ff0000"/>
                </a:solidFill>
                <a:latin typeface="Courier New"/>
                <a:ea typeface="Courier New"/>
              </a:rPr>
              <a:t>GTCAT&lt;&gt;AGTAC</a:t>
            </a: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ATCAGACCTCCACCGT--GAAGGTATGGCCCTTGGGAA 206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41250-41550bp_      GTATTGGGCGGGC</a:t>
            </a:r>
            <a:r>
              <a:rPr b="0" lang="fr-FR" sz="900" spc="-1" strike="noStrike">
                <a:solidFill>
                  <a:srgbClr val="ff0000"/>
                </a:solidFill>
                <a:latin typeface="Courier New"/>
                <a:ea typeface="Courier New"/>
              </a:rPr>
              <a:t>GTCAT&lt;&gt;AGTAC</a:t>
            </a: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ACACCCTAG--------GCCGG-AGGTCCGAACCGAT 206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43400-43700bp_      CTG--GGGCG--C</a:t>
            </a:r>
            <a:r>
              <a:rPr b="0" lang="fr-FR" sz="900" spc="-1" strike="noStrike">
                <a:solidFill>
                  <a:srgbClr val="ff0000"/>
                </a:solidFill>
                <a:latin typeface="Courier New"/>
                <a:ea typeface="Courier New"/>
              </a:rPr>
              <a:t>GTCAT&lt;&gt;AGTAC</a:t>
            </a:r>
            <a:r>
              <a:rPr b="0" lang="fr-FR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ACACCCCAG--------GCGCA-CCCGGCGTTACGCT 20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13T15:53:14Z</dcterms:created>
  <dc:creator>Christine</dc:creator>
  <dc:description/>
  <dc:language>en-US</dc:language>
  <cp:lastModifiedBy>Christine</cp:lastModifiedBy>
  <dcterms:modified xsi:type="dcterms:W3CDTF">2013-02-15T20:52:51Z</dcterms:modified>
  <cp:revision>16</cp:revision>
  <dc:subject/>
  <dc:title>Diapositive 1</dc:title>
</cp:coreProperties>
</file>